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0AD4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4674"/>
  </p:normalViewPr>
  <p:slideViewPr>
    <p:cSldViewPr snapToGrid="0" snapToObjects="1">
      <p:cViewPr varScale="1">
        <p:scale>
          <a:sx n="104" d="100"/>
          <a:sy n="104" d="100"/>
        </p:scale>
        <p:origin x="114" y="3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ppe1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ppe1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ppe1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ppe1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ppe1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veren\Documents\Uni\RAREFACTION_Paper\eveness_inequality_gini\sample_distribution_excel_graphic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3"/>
            </a:solidFill>
          </c:spPr>
          <c:invertIfNegative val="0"/>
          <c:dLbls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Tabelle1!$B$22:$E$22</c:f>
              <c:strCache>
                <c:ptCount val="4"/>
                <c:pt idx="0">
                  <c:v>high</c:v>
                </c:pt>
                <c:pt idx="1">
                  <c:v>good</c:v>
                </c:pt>
                <c:pt idx="2">
                  <c:v>moderate</c:v>
                </c:pt>
                <c:pt idx="3">
                  <c:v>poor</c:v>
                </c:pt>
              </c:strCache>
            </c:strRef>
          </c:cat>
          <c:val>
            <c:numRef>
              <c:f>Tabelle1!$B$23:$E$23</c:f>
              <c:numCache>
                <c:formatCode>General</c:formatCode>
                <c:ptCount val="4"/>
                <c:pt idx="0">
                  <c:v>8</c:v>
                </c:pt>
                <c:pt idx="1">
                  <c:v>9</c:v>
                </c:pt>
                <c:pt idx="2">
                  <c:v>12</c:v>
                </c:pt>
                <c:pt idx="3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639-BC4A-ABB3-B92FF1B450D4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123548032"/>
        <c:axId val="123549568"/>
      </c:barChart>
      <c:catAx>
        <c:axId val="1235480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23549568"/>
        <c:crosses val="autoZero"/>
        <c:auto val="1"/>
        <c:lblAlgn val="ctr"/>
        <c:lblOffset val="100"/>
        <c:noMultiLvlLbl val="0"/>
      </c:catAx>
      <c:valAx>
        <c:axId val="123549568"/>
        <c:scaling>
          <c:orientation val="minMax"/>
        </c:scaling>
        <c:delete val="1"/>
        <c:axPos val="l"/>
        <c:numFmt formatCode="General" sourceLinked="1"/>
        <c:majorTickMark val="out"/>
        <c:minorTickMark val="none"/>
        <c:tickLblPos val="nextTo"/>
        <c:crossAx val="12354803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Lbls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Tabelle1!$B$40:$D$40</c:f>
              <c:strCache>
                <c:ptCount val="3"/>
                <c:pt idx="0">
                  <c:v>China</c:v>
                </c:pt>
                <c:pt idx="1">
                  <c:v>Singapore</c:v>
                </c:pt>
                <c:pt idx="2">
                  <c:v>USA</c:v>
                </c:pt>
              </c:strCache>
            </c:strRef>
          </c:cat>
          <c:val>
            <c:numRef>
              <c:f>Tabelle1!$B$41:$D$41</c:f>
              <c:numCache>
                <c:formatCode>General</c:formatCode>
                <c:ptCount val="3"/>
                <c:pt idx="0">
                  <c:v>12</c:v>
                </c:pt>
                <c:pt idx="1">
                  <c:v>16</c:v>
                </c:pt>
                <c:pt idx="2">
                  <c:v>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CFB-F44F-91EF-611EBD54081D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123573376"/>
        <c:axId val="123574912"/>
      </c:barChart>
      <c:catAx>
        <c:axId val="1235733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23574912"/>
        <c:crosses val="autoZero"/>
        <c:auto val="1"/>
        <c:lblAlgn val="ctr"/>
        <c:lblOffset val="100"/>
        <c:noMultiLvlLbl val="0"/>
      </c:catAx>
      <c:valAx>
        <c:axId val="123574912"/>
        <c:scaling>
          <c:orientation val="minMax"/>
        </c:scaling>
        <c:delete val="1"/>
        <c:axPos val="l"/>
        <c:numFmt formatCode="General" sourceLinked="1"/>
        <c:majorTickMark val="out"/>
        <c:minorTickMark val="none"/>
        <c:tickLblPos val="nextTo"/>
        <c:crossAx val="12357337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6"/>
    </mc:Choice>
    <mc:Fallback>
      <c:style val="6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Lbls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Tabelle1!$B$56:$F$56</c:f>
              <c:strCache>
                <c:ptCount val="5"/>
                <c:pt idx="0">
                  <c:v>Ak</c:v>
                </c:pt>
                <c:pt idx="1">
                  <c:v>Bt</c:v>
                </c:pt>
                <c:pt idx="2">
                  <c:v>Bj</c:v>
                </c:pt>
                <c:pt idx="3">
                  <c:v>Nk</c:v>
                </c:pt>
                <c:pt idx="4">
                  <c:v>St</c:v>
                </c:pt>
              </c:strCache>
            </c:strRef>
          </c:cat>
          <c:val>
            <c:numRef>
              <c:f>Tabelle1!$B$57:$F$57</c:f>
              <c:numCache>
                <c:formatCode>General</c:formatCode>
                <c:ptCount val="5"/>
                <c:pt idx="0">
                  <c:v>16</c:v>
                </c:pt>
                <c:pt idx="1">
                  <c:v>19</c:v>
                </c:pt>
                <c:pt idx="2">
                  <c:v>17</c:v>
                </c:pt>
                <c:pt idx="3">
                  <c:v>16</c:v>
                </c:pt>
                <c:pt idx="4">
                  <c:v>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D88-E54D-8105-63C438ABBF57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123615104"/>
        <c:axId val="123616640"/>
      </c:barChart>
      <c:catAx>
        <c:axId val="1236151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23616640"/>
        <c:crosses val="autoZero"/>
        <c:auto val="1"/>
        <c:lblAlgn val="ctr"/>
        <c:lblOffset val="100"/>
        <c:noMultiLvlLbl val="0"/>
      </c:catAx>
      <c:valAx>
        <c:axId val="123616640"/>
        <c:scaling>
          <c:orientation val="minMax"/>
        </c:scaling>
        <c:delete val="1"/>
        <c:axPos val="l"/>
        <c:numFmt formatCode="General" sourceLinked="1"/>
        <c:majorTickMark val="out"/>
        <c:minorTickMark val="none"/>
        <c:tickLblPos val="nextTo"/>
        <c:crossAx val="12361510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6"/>
    </mc:Choice>
    <mc:Fallback>
      <c:style val="6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Lbls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Tabelle1!$B$62:$E$62</c:f>
              <c:strCache>
                <c:ptCount val="4"/>
                <c:pt idx="0">
                  <c:v>good</c:v>
                </c:pt>
                <c:pt idx="1">
                  <c:v>moderate</c:v>
                </c:pt>
                <c:pt idx="2">
                  <c:v>poor</c:v>
                </c:pt>
                <c:pt idx="3">
                  <c:v>bad</c:v>
                </c:pt>
              </c:strCache>
            </c:strRef>
          </c:cat>
          <c:val>
            <c:numRef>
              <c:f>Tabelle1!$B$63:$E$63</c:f>
              <c:numCache>
                <c:formatCode>General</c:formatCode>
                <c:ptCount val="4"/>
                <c:pt idx="0">
                  <c:v>52</c:v>
                </c:pt>
                <c:pt idx="1">
                  <c:v>5</c:v>
                </c:pt>
                <c:pt idx="2">
                  <c:v>10</c:v>
                </c:pt>
                <c:pt idx="3">
                  <c:v>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4E4-1B48-98E9-531484911C4F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123640448"/>
        <c:axId val="123658624"/>
      </c:barChart>
      <c:catAx>
        <c:axId val="1236404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23658624"/>
        <c:crosses val="autoZero"/>
        <c:auto val="1"/>
        <c:lblAlgn val="ctr"/>
        <c:lblOffset val="100"/>
        <c:noMultiLvlLbl val="0"/>
      </c:catAx>
      <c:valAx>
        <c:axId val="123658624"/>
        <c:scaling>
          <c:orientation val="minMax"/>
        </c:scaling>
        <c:delete val="1"/>
        <c:axPos val="l"/>
        <c:numFmt formatCode="General" sourceLinked="1"/>
        <c:majorTickMark val="out"/>
        <c:minorTickMark val="none"/>
        <c:tickLblPos val="nextTo"/>
        <c:crossAx val="12364044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6"/>
            </a:solidFill>
          </c:spPr>
          <c:invertIfNegative val="0"/>
          <c:dLbls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Tabelle1!$B$1:$D$1</c:f>
              <c:strCache>
                <c:ptCount val="3"/>
                <c:pt idx="0">
                  <c:v>CE</c:v>
                </c:pt>
                <c:pt idx="1">
                  <c:v>AZE</c:v>
                </c:pt>
                <c:pt idx="2">
                  <c:v>REF</c:v>
                </c:pt>
              </c:strCache>
            </c:strRef>
          </c:cat>
          <c:val>
            <c:numRef>
              <c:f>Tabelle1!$B$2:$D$2</c:f>
              <c:numCache>
                <c:formatCode>General</c:formatCode>
                <c:ptCount val="3"/>
                <c:pt idx="0">
                  <c:v>28</c:v>
                </c:pt>
                <c:pt idx="1">
                  <c:v>24</c:v>
                </c:pt>
                <c:pt idx="2">
                  <c:v>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459-0946-892B-E5AE53FF13AE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123665792"/>
        <c:axId val="123667584"/>
      </c:barChart>
      <c:catAx>
        <c:axId val="12366579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23667584"/>
        <c:crosses val="autoZero"/>
        <c:auto val="1"/>
        <c:lblAlgn val="ctr"/>
        <c:lblOffset val="100"/>
        <c:noMultiLvlLbl val="0"/>
      </c:catAx>
      <c:valAx>
        <c:axId val="123667584"/>
        <c:scaling>
          <c:orientation val="minMax"/>
        </c:scaling>
        <c:delete val="1"/>
        <c:axPos val="l"/>
        <c:numFmt formatCode="General" sourceLinked="1"/>
        <c:majorTickMark val="out"/>
        <c:minorTickMark val="none"/>
        <c:tickLblPos val="nextTo"/>
        <c:crossAx val="12366579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70AD47"/>
            </a:solidFill>
          </c:spPr>
          <c:invertIfNegative val="0"/>
          <c:dLbls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Tabelle1!$B$4:$D$4</c:f>
              <c:strCache>
                <c:ptCount val="3"/>
                <c:pt idx="0">
                  <c:v>pre-production phase</c:v>
                </c:pt>
                <c:pt idx="1">
                  <c:v>early production phase</c:v>
                </c:pt>
                <c:pt idx="2">
                  <c:v>late production phase</c:v>
                </c:pt>
              </c:strCache>
            </c:strRef>
          </c:cat>
          <c:val>
            <c:numRef>
              <c:f>Tabelle1!$B$5:$D$5</c:f>
              <c:numCache>
                <c:formatCode>General</c:formatCode>
                <c:ptCount val="3"/>
                <c:pt idx="0">
                  <c:v>25</c:v>
                </c:pt>
                <c:pt idx="1">
                  <c:v>24</c:v>
                </c:pt>
                <c:pt idx="2">
                  <c:v>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C50-46B9-91D7-6393E72FBEB9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66074112"/>
        <c:axId val="66127360"/>
      </c:barChart>
      <c:catAx>
        <c:axId val="6607411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66127360"/>
        <c:crosses val="autoZero"/>
        <c:auto val="1"/>
        <c:lblAlgn val="ctr"/>
        <c:lblOffset val="100"/>
        <c:noMultiLvlLbl val="0"/>
      </c:catAx>
      <c:valAx>
        <c:axId val="66127360"/>
        <c:scaling>
          <c:orientation val="minMax"/>
        </c:scaling>
        <c:delete val="1"/>
        <c:axPos val="l"/>
        <c:numFmt formatCode="General" sourceLinked="1"/>
        <c:majorTickMark val="out"/>
        <c:minorTickMark val="none"/>
        <c:tickLblPos val="nextTo"/>
        <c:crossAx val="6607411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3C9192B-2405-E84A-840C-75B0DE83AC0E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09EF34-00B6-8046-8150-6190AAFDC2A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98125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1A56315-54F5-4662-85BE-F9D5F844A593}" type="slidenum">
              <a:rPr lang="de-DE" smtClean="0"/>
              <a:pPr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060596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4E27C2-9DF0-7444-B1F2-07D6E3D6B40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B6B0541-E45F-0946-A9B1-BC5E5AAE912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7366A8-1549-CD49-B126-8F39935A9F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F130B-995B-0643-835C-F27EA038AC54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17DF8F-FB72-3549-BF9F-44C0C549D4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3F8C5C-2E6F-004D-87A7-7D528CFBEF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54F79-2A15-7844-B0EC-F3069777215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78728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C1C99A-D5F1-8F40-88EC-4AA6FF983B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73218E3-E87D-3A48-B179-DEC6571BD5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A2AC58-67D0-764E-A832-4DE17B9383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F130B-995B-0643-835C-F27EA038AC54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2B5955-7C88-2C42-92D1-CE16810B17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2F6EC7-DE1C-FE49-91C2-A6192DC9CB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54F79-2A15-7844-B0EC-F3069777215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78066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5B25D52-8317-384B-81EE-BFAA0EAFD7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776CAD5-8C66-9646-A095-41414F7F53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15DA48-887D-D14F-A19F-D254EDE3E8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F130B-995B-0643-835C-F27EA038AC54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25E133-12AE-1246-B46E-7BBBADEEEE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40BC79-CC63-5F4E-8C1A-7ED1963C5E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54F79-2A15-7844-B0EC-F3069777215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9755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3648AC-724C-E749-AD84-A8277D000D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584DD5-6964-4D42-9016-E2B5AE3623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2FA350-5405-E046-B274-47FC065012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F130B-995B-0643-835C-F27EA038AC54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C4A54D-C9A7-564B-8E07-1CA096C4BF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08E34B-5858-A24C-93F8-C9E692ABFE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54F79-2A15-7844-B0EC-F3069777215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72328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BDA818-2BAC-6044-83CC-891CD59234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B0B434-1DDE-6D43-A6DF-BF2E14DC08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40891F-0735-CD49-9A61-59FDF95A9E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F130B-995B-0643-835C-F27EA038AC54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17CAF5-7ED1-8543-B5F4-F325508D75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9CD2CD-A36B-074D-9169-4C730D2EC7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54F79-2A15-7844-B0EC-F3069777215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25678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B8580B-0D3C-3D48-A359-97121C58F0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77B92F-39F1-4141-BE78-D01B394622D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813A555-01C8-E947-993B-48513A2474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CE0B45-F071-9943-AD35-C1097E1081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F130B-995B-0643-835C-F27EA038AC54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F17F34-4B88-2C4C-9809-AE9D1EC7F8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B6F2081-E8E3-B84A-8ECA-4F4DA7A49B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54F79-2A15-7844-B0EC-F3069777215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107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09FCA7-A784-3E44-A597-C497006C25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32A08C-70E3-EF4B-A017-6C7022D4D1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B9DA9C8-8B83-0A4D-B8B9-E836C2CF0D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EEA87A4-BCB9-5944-BAC1-A7589489EF2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66DECF9-A20E-1E4D-8024-A92D79A8AF0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397C13C-4AAA-F641-8C83-9B436269EE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F130B-995B-0643-835C-F27EA038AC54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4E55FFC-7618-A14A-A66A-A9D6643361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35379E0-C476-274F-A63E-FAE2228C8D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54F79-2A15-7844-B0EC-F3069777215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16446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9E8E26-90DD-D54B-8D71-E24989C8B6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3CECBDD-8D28-CD41-BBCA-18F68D5E39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F130B-995B-0643-835C-F27EA038AC54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3CC08E1-DEDD-564B-9451-04EC89A20E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3E286A8-21B9-334B-AA51-3D589E613E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54F79-2A15-7844-B0EC-F3069777215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1078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C9DCA45-EDE0-B349-A2CC-6D98415386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F130B-995B-0643-835C-F27EA038AC54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7B2369A-7253-5B45-BEFA-BE35BE3B01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46087C-912A-8D4C-9B81-BFA6631464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54F79-2A15-7844-B0EC-F3069777215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72195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E6DEC8-C932-514F-AB48-482419C811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E88559-4AD3-584F-9B98-BC289F1BC23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EA8CCD-15A2-F048-9BFF-D963D01A7D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CC8A09-ABA2-B54B-8C27-53A460D5AD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F130B-995B-0643-835C-F27EA038AC54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CAA7E6-0E39-1C4D-991A-927945DFD0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B66281-7200-7747-B25B-0455D4E604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54F79-2A15-7844-B0EC-F3069777215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07642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137D74-0622-AB4A-8266-0F4C12D96A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465D44A-5DA7-0641-BE33-727A58D89D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5125647-9A9F-0E4B-A05D-968C0DBC1B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9E360C2-54C3-1B47-9D29-FDDDFC5130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F130B-995B-0643-835C-F27EA038AC54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81BB6E-2458-0C49-8903-BC327834E7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A64BB6-433D-9840-BA98-0184827119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54F79-2A15-7844-B0EC-F3069777215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005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EFA7DD9-F447-B149-8B8A-511CE56E9D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3ECAB1-DFE4-A34A-9A22-D59415D459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4730EF-B9C4-A843-B13C-DE8A05C7348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9F130B-995B-0643-835C-F27EA038AC54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69D5F1-9E0F-FD4C-B341-E81086D3080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143B54-6949-024F-836A-B0BD5AE2A8B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D54F79-2A15-7844-B0EC-F3069777215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968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458BB81D-3DDF-AA4F-BEB3-AC632B6D24A7}"/>
              </a:ext>
            </a:extLst>
          </p:cNvPr>
          <p:cNvGrpSpPr/>
          <p:nvPr/>
        </p:nvGrpSpPr>
        <p:grpSpPr>
          <a:xfrm>
            <a:off x="380960" y="1251484"/>
            <a:ext cx="10530033" cy="5339521"/>
            <a:chOff x="380960" y="344977"/>
            <a:chExt cx="11290774" cy="6246028"/>
          </a:xfrm>
        </p:grpSpPr>
        <p:sp>
          <p:nvSpPr>
            <p:cNvPr id="10" name="Textfeld 9"/>
            <p:cNvSpPr txBox="1"/>
            <p:nvPr/>
          </p:nvSpPr>
          <p:spPr>
            <a:xfrm>
              <a:off x="571461" y="380980"/>
              <a:ext cx="1394575" cy="3960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/>
                <a:t>ScoSa Station</a:t>
              </a:r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571461" y="3619502"/>
              <a:ext cx="1763708" cy="684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/>
                <a:t>ScoSa salmon</a:t>
              </a:r>
            </a:p>
            <a:p>
              <a:r>
                <a:rPr lang="de-DE" sz="1600"/>
                <a:t>production phase</a:t>
              </a:r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4317888" y="380980"/>
              <a:ext cx="1894337" cy="3960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err="1"/>
                <a:t>BasCo</a:t>
              </a:r>
              <a:r>
                <a:rPr lang="de-DE" sz="1600" dirty="0"/>
                <a:t> </a:t>
              </a:r>
              <a:r>
                <a:rPr lang="de-DE" sz="1600" dirty="0" err="1"/>
                <a:t>microgAMBI</a:t>
              </a:r>
              <a:endParaRPr lang="de-DE" sz="1600" dirty="0"/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4317887" y="3619502"/>
              <a:ext cx="1579931" cy="3960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/>
                <a:t>BallWa Country</a:t>
              </a:r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8286765" y="380980"/>
              <a:ext cx="2010116" cy="3960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err="1"/>
                <a:t>NorSa</a:t>
              </a:r>
              <a:r>
                <a:rPr lang="de-DE" sz="1600" dirty="0"/>
                <a:t> Farm </a:t>
              </a:r>
              <a:r>
                <a:rPr lang="de-DE" sz="1600" dirty="0" err="1"/>
                <a:t>location</a:t>
              </a:r>
              <a:endParaRPr lang="de-DE" sz="1600" dirty="0"/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8286766" y="3619502"/>
              <a:ext cx="1280859" cy="3960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err="1"/>
                <a:t>NorSa</a:t>
              </a:r>
              <a:r>
                <a:rPr lang="de-DE" sz="1600" dirty="0"/>
                <a:t> AMBI</a:t>
              </a:r>
            </a:p>
          </p:txBody>
        </p:sp>
        <p:graphicFrame>
          <p:nvGraphicFramePr>
            <p:cNvPr id="39" name="Diagramm 38"/>
            <p:cNvGraphicFramePr/>
            <p:nvPr>
              <p:extLst>
                <p:ext uri="{D42A27DB-BD31-4B8C-83A1-F6EECF244321}">
                  <p14:modId xmlns:p14="http://schemas.microsoft.com/office/powerpoint/2010/main" val="1027656448"/>
                </p:ext>
              </p:extLst>
            </p:nvPr>
          </p:nvGraphicFramePr>
          <p:xfrm>
            <a:off x="4190987" y="952483"/>
            <a:ext cx="3360000" cy="24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40" name="Diagramm 39"/>
            <p:cNvGraphicFramePr/>
            <p:nvPr>
              <p:extLst>
                <p:ext uri="{D42A27DB-BD31-4B8C-83A1-F6EECF244321}">
                  <p14:modId xmlns:p14="http://schemas.microsoft.com/office/powerpoint/2010/main" val="992973134"/>
                </p:ext>
              </p:extLst>
            </p:nvPr>
          </p:nvGraphicFramePr>
          <p:xfrm>
            <a:off x="4190987" y="4191005"/>
            <a:ext cx="3360000" cy="24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41" name="Diagramm 40"/>
            <p:cNvGraphicFramePr/>
            <p:nvPr>
              <p:extLst>
                <p:ext uri="{D42A27DB-BD31-4B8C-83A1-F6EECF244321}">
                  <p14:modId xmlns:p14="http://schemas.microsoft.com/office/powerpoint/2010/main" val="1652665645"/>
                </p:ext>
              </p:extLst>
            </p:nvPr>
          </p:nvGraphicFramePr>
          <p:xfrm>
            <a:off x="8096264" y="952483"/>
            <a:ext cx="3360000" cy="24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42" name="Diagramm 41"/>
            <p:cNvGraphicFramePr/>
            <p:nvPr>
              <p:extLst>
                <p:ext uri="{D42A27DB-BD31-4B8C-83A1-F6EECF244321}">
                  <p14:modId xmlns:p14="http://schemas.microsoft.com/office/powerpoint/2010/main" val="3858264317"/>
                </p:ext>
              </p:extLst>
            </p:nvPr>
          </p:nvGraphicFramePr>
          <p:xfrm>
            <a:off x="8001013" y="4191005"/>
            <a:ext cx="3360000" cy="24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43" name="Diagramm 42"/>
            <p:cNvGraphicFramePr/>
            <p:nvPr>
              <p:extLst>
                <p:ext uri="{D42A27DB-BD31-4B8C-83A1-F6EECF244321}">
                  <p14:modId xmlns:p14="http://schemas.microsoft.com/office/powerpoint/2010/main" val="342937356"/>
                </p:ext>
              </p:extLst>
            </p:nvPr>
          </p:nvGraphicFramePr>
          <p:xfrm>
            <a:off x="380960" y="952483"/>
            <a:ext cx="3360000" cy="24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44" name="Textfeld 43"/>
            <p:cNvSpPr txBox="1"/>
            <p:nvPr/>
          </p:nvSpPr>
          <p:spPr>
            <a:xfrm>
              <a:off x="2571726" y="380980"/>
              <a:ext cx="1232732" cy="4320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err="1">
                  <a:solidFill>
                    <a:srgbClr val="FF0000"/>
                  </a:solidFill>
                </a:rPr>
                <a:t>Gini</a:t>
              </a:r>
              <a:r>
                <a:rPr lang="de-DE" b="1" dirty="0">
                  <a:solidFill>
                    <a:srgbClr val="FF0000"/>
                  </a:solidFill>
                </a:rPr>
                <a:t> 0.035</a:t>
              </a:r>
            </a:p>
          </p:txBody>
        </p:sp>
        <p:sp>
          <p:nvSpPr>
            <p:cNvPr id="45" name="Textfeld 44"/>
            <p:cNvSpPr txBox="1"/>
            <p:nvPr/>
          </p:nvSpPr>
          <p:spPr>
            <a:xfrm>
              <a:off x="2571726" y="3619502"/>
              <a:ext cx="1232732" cy="4320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err="1">
                  <a:solidFill>
                    <a:srgbClr val="FF0000"/>
                  </a:solidFill>
                </a:rPr>
                <a:t>Gini</a:t>
              </a:r>
              <a:r>
                <a:rPr lang="de-DE" b="1" dirty="0">
                  <a:solidFill>
                    <a:srgbClr val="FF0000"/>
                  </a:solidFill>
                </a:rPr>
                <a:t> 0.026</a:t>
              </a:r>
            </a:p>
          </p:txBody>
        </p:sp>
        <p:sp>
          <p:nvSpPr>
            <p:cNvPr id="46" name="Textfeld 45"/>
            <p:cNvSpPr txBox="1"/>
            <p:nvPr/>
          </p:nvSpPr>
          <p:spPr>
            <a:xfrm>
              <a:off x="6318255" y="344977"/>
              <a:ext cx="1232732" cy="4320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err="1">
                  <a:solidFill>
                    <a:srgbClr val="FF0000"/>
                  </a:solidFill>
                </a:rPr>
                <a:t>Gini</a:t>
              </a:r>
              <a:r>
                <a:rPr lang="de-DE" b="1" dirty="0">
                  <a:solidFill>
                    <a:srgbClr val="FF0000"/>
                  </a:solidFill>
                </a:rPr>
                <a:t> 0.083</a:t>
              </a:r>
            </a:p>
          </p:txBody>
        </p:sp>
        <p:sp>
          <p:nvSpPr>
            <p:cNvPr id="47" name="Textfeld 46"/>
            <p:cNvSpPr txBox="1"/>
            <p:nvPr/>
          </p:nvSpPr>
          <p:spPr>
            <a:xfrm>
              <a:off x="6477003" y="3619502"/>
              <a:ext cx="1232732" cy="4320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err="1">
                  <a:solidFill>
                    <a:srgbClr val="FF0000"/>
                  </a:solidFill>
                </a:rPr>
                <a:t>Gini</a:t>
              </a:r>
              <a:r>
                <a:rPr lang="de-DE" b="1" dirty="0">
                  <a:solidFill>
                    <a:srgbClr val="FF0000"/>
                  </a:solidFill>
                </a:rPr>
                <a:t> 0.215</a:t>
              </a:r>
            </a:p>
          </p:txBody>
        </p:sp>
        <p:sp>
          <p:nvSpPr>
            <p:cNvPr id="48" name="Textfeld 47"/>
            <p:cNvSpPr txBox="1"/>
            <p:nvPr/>
          </p:nvSpPr>
          <p:spPr>
            <a:xfrm>
              <a:off x="10382281" y="380980"/>
              <a:ext cx="1289453" cy="4320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err="1">
                  <a:solidFill>
                    <a:srgbClr val="FF0000"/>
                  </a:solidFill>
                </a:rPr>
                <a:t>Gini</a:t>
              </a:r>
              <a:r>
                <a:rPr lang="de-DE" b="1" dirty="0">
                  <a:solidFill>
                    <a:srgbClr val="FF0000"/>
                  </a:solidFill>
                </a:rPr>
                <a:t> 0.105 </a:t>
              </a:r>
            </a:p>
          </p:txBody>
        </p:sp>
        <p:sp>
          <p:nvSpPr>
            <p:cNvPr id="49" name="Textfeld 48"/>
            <p:cNvSpPr txBox="1"/>
            <p:nvPr/>
          </p:nvSpPr>
          <p:spPr>
            <a:xfrm>
              <a:off x="10287031" y="3619502"/>
              <a:ext cx="1232732" cy="4320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err="1">
                  <a:solidFill>
                    <a:srgbClr val="FF0000"/>
                  </a:solidFill>
                </a:rPr>
                <a:t>Gini</a:t>
              </a:r>
              <a:r>
                <a:rPr lang="de-DE" b="1" dirty="0">
                  <a:solidFill>
                    <a:srgbClr val="FF0000"/>
                  </a:solidFill>
                </a:rPr>
                <a:t> 0.418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FCCBEDF2-005E-5247-AA7C-7895AADB51D2}"/>
              </a:ext>
            </a:extLst>
          </p:cNvPr>
          <p:cNvSpPr txBox="1"/>
          <p:nvPr/>
        </p:nvSpPr>
        <p:spPr>
          <a:xfrm>
            <a:off x="213934" y="167855"/>
            <a:ext cx="11210794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i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le 3: </a:t>
            </a:r>
            <a:r>
              <a:rPr lang="en-US" sz="1400"/>
              <a:t>Class </a:t>
            </a:r>
            <a:r>
              <a:rPr lang="en-US" sz="1400" dirty="0"/>
              <a:t>frequency distribution in individual data sets visualized in bar plots and calculated with Gini coefficient. Higher Gini coefficient values indicate a higher imbalance (max Gini coefficient = 1). Despite </a:t>
            </a:r>
            <a:r>
              <a:rPr lang="en-US" sz="1400"/>
              <a:t>both ScoSa </a:t>
            </a:r>
            <a:r>
              <a:rPr lang="en-US" sz="1400" dirty="0"/>
              <a:t>datasets (Station </a:t>
            </a:r>
            <a:r>
              <a:rPr lang="en-US" sz="1400"/>
              <a:t>and salmon production phase) </a:t>
            </a:r>
            <a:r>
              <a:rPr lang="en-US" sz="1400" dirty="0"/>
              <a:t>have highly similar Gini coefficients, the difference in the minimum number of observations required for targeted RF prediction performance is maximal (50 sequences/sample versus 5000 sequences per sample).</a:t>
            </a:r>
          </a:p>
        </p:txBody>
      </p:sp>
      <p:graphicFrame>
        <p:nvGraphicFramePr>
          <p:cNvPr id="22" name="Diagramm 21">
            <a:extLst>
              <a:ext uri="{FF2B5EF4-FFF2-40B4-BE49-F238E27FC236}">
                <a16:creationId xmlns:a16="http://schemas.microsoft.com/office/drawing/2014/main" id="{00000000-0008-0000-00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1419075"/>
              </p:ext>
            </p:extLst>
          </p:nvPr>
        </p:nvGraphicFramePr>
        <p:xfrm>
          <a:off x="198815" y="4700305"/>
          <a:ext cx="3315758" cy="20267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</p:spTree>
    <p:extLst>
      <p:ext uri="{BB962C8B-B14F-4D97-AF65-F5344CB8AC3E}">
        <p14:creationId xmlns:p14="http://schemas.microsoft.com/office/powerpoint/2010/main" val="15348744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380960" y="3263504"/>
            <a:ext cx="7048549" cy="3594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476211" y="-23"/>
            <a:ext cx="6762796" cy="34135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Textfeld 3"/>
          <p:cNvSpPr txBox="1"/>
          <p:nvPr/>
        </p:nvSpPr>
        <p:spPr>
          <a:xfrm>
            <a:off x="7810512" y="2095492"/>
            <a:ext cx="10438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/>
              <a:t>p=0.56</a:t>
            </a:r>
          </a:p>
        </p:txBody>
      </p:sp>
      <p:sp>
        <p:nvSpPr>
          <p:cNvPr id="5" name="Textfeld 4"/>
          <p:cNvSpPr txBox="1"/>
          <p:nvPr/>
        </p:nvSpPr>
        <p:spPr>
          <a:xfrm>
            <a:off x="7810512" y="5524516"/>
            <a:ext cx="10438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/>
              <a:t>p=0.5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806DC19-9E54-9B45-9423-F327FC129A54}"/>
              </a:ext>
            </a:extLst>
          </p:cNvPr>
          <p:cNvSpPr txBox="1"/>
          <p:nvPr/>
        </p:nvSpPr>
        <p:spPr>
          <a:xfrm>
            <a:off x="7815237" y="2769514"/>
            <a:ext cx="3995803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lotting class frequency distributions (Gini coefficient) against minimum number of observations required for targeted RF prediction performance (as measured by kappa and out-of-bag error) shows a lack of correlation between these two parameter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E2D50F5-69E6-9944-8AA7-1036A24A068A}"/>
              </a:ext>
            </a:extLst>
          </p:cNvPr>
          <p:cNvSpPr txBox="1"/>
          <p:nvPr/>
        </p:nvSpPr>
        <p:spPr>
          <a:xfrm rot="16200000">
            <a:off x="-75705" y="1245802"/>
            <a:ext cx="1282659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Gini coefficien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BFAE9CA-28E5-0E4B-A2A0-4D621069612E}"/>
              </a:ext>
            </a:extLst>
          </p:cNvPr>
          <p:cNvSpPr txBox="1"/>
          <p:nvPr/>
        </p:nvSpPr>
        <p:spPr>
          <a:xfrm rot="16200000">
            <a:off x="-165119" y="4574911"/>
            <a:ext cx="1282659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Gini coefficien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CF718CF-E6BD-1849-AD9C-7838F1B93DC8}"/>
              </a:ext>
            </a:extLst>
          </p:cNvPr>
          <p:cNvSpPr txBox="1"/>
          <p:nvPr/>
        </p:nvSpPr>
        <p:spPr>
          <a:xfrm>
            <a:off x="1056514" y="2965678"/>
            <a:ext cx="6277744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Min n observation within a sample required for targeted RF prediction performanc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D22842C-0A38-E249-8F86-EEF26493CB7D}"/>
              </a:ext>
            </a:extLst>
          </p:cNvPr>
          <p:cNvSpPr txBox="1"/>
          <p:nvPr/>
        </p:nvSpPr>
        <p:spPr>
          <a:xfrm>
            <a:off x="1056514" y="6508175"/>
            <a:ext cx="6277744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Min n observation within a sample required for targeted RF prediction performance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47AF26EA-941F-9A41-9797-A7AD9EC2DEED}"/>
              </a:ext>
            </a:extLst>
          </p:cNvPr>
          <p:cNvSpPr/>
          <p:nvPr/>
        </p:nvSpPr>
        <p:spPr>
          <a:xfrm>
            <a:off x="3494762" y="3225926"/>
            <a:ext cx="1503123" cy="1500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0318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9</Words>
  <Application>Microsoft Office PowerPoint</Application>
  <PresentationFormat>Breitbild</PresentationFormat>
  <Paragraphs>22</Paragraphs>
  <Slides>2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orsten Stoeck</dc:creator>
  <cp:lastModifiedBy>Verena Dully</cp:lastModifiedBy>
  <cp:revision>9</cp:revision>
  <dcterms:created xsi:type="dcterms:W3CDTF">2020-12-15T15:56:00Z</dcterms:created>
  <dcterms:modified xsi:type="dcterms:W3CDTF">2021-03-23T13:27:03Z</dcterms:modified>
</cp:coreProperties>
</file>